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1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3444" y="-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CCB43B-9BE6-49EC-AE90-4684DFF53935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BF24A5-E1BD-4957-B190-A22A2E06509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41940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BF24A5-E1BD-4957-B190-A22A2E06509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71659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2977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044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018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378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923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643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9051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24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7353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457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0216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59C628-4FBC-4A45-A505-ED2042EF0EE8}" type="datetimeFigureOut">
              <a:rPr kumimoji="1" lang="ja-JP" altLang="en-US" smtClean="0"/>
              <a:t>2017/3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0A7375-2358-4466-AE6F-83A5A7BE7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922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4960" y="6848883"/>
            <a:ext cx="1420170" cy="10216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2791" y="3018613"/>
            <a:ext cx="1472643" cy="10669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2033" y="1192316"/>
            <a:ext cx="1456167" cy="10603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" name="テキスト ボックス 71"/>
          <p:cNvSpPr txBox="1"/>
          <p:nvPr/>
        </p:nvSpPr>
        <p:spPr>
          <a:xfrm>
            <a:off x="1225874" y="6504072"/>
            <a:ext cx="35395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 or four vascular risk factors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 = 45)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 rot="16200000">
            <a:off x="277778" y="7210964"/>
            <a:ext cx="1111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1847322" y="7981492"/>
            <a:ext cx="16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r>
              <a:rPr lang="en-US" altLang="ja-JP" sz="1400" dirty="0" smtClean="0"/>
              <a:t> </a:t>
            </a: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2645339" y="6782408"/>
            <a:ext cx="7667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1</a:t>
            </a:r>
            <a:endParaRPr kumimoji="1"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1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テキスト ボックス 110"/>
          <p:cNvSpPr txBox="1"/>
          <p:nvPr/>
        </p:nvSpPr>
        <p:spPr>
          <a:xfrm>
            <a:off x="1840827" y="4223384"/>
            <a:ext cx="6989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/>
          <p:cNvSpPr txBox="1"/>
          <p:nvPr/>
        </p:nvSpPr>
        <p:spPr>
          <a:xfrm rot="16200000">
            <a:off x="237116" y="3392225"/>
            <a:ext cx="11880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1250804" y="2717240"/>
            <a:ext cx="3304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e vascular risk factor</a:t>
            </a:r>
            <a:r>
              <a:rPr kumimoji="1"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 = 55)</a:t>
            </a:r>
          </a:p>
        </p:txBody>
      </p:sp>
      <p:sp>
        <p:nvSpPr>
          <p:cNvPr id="117" name="テキスト ボックス 116"/>
          <p:cNvSpPr txBox="1"/>
          <p:nvPr/>
        </p:nvSpPr>
        <p:spPr>
          <a:xfrm>
            <a:off x="2658630" y="3007855"/>
            <a:ext cx="8625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= -0.24</a:t>
            </a: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= 0.0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 rot="16200000">
            <a:off x="269827" y="1604352"/>
            <a:ext cx="11225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</a:t>
            </a:r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GF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1849991" y="2393992"/>
            <a:ext cx="1600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2639763" y="1136827"/>
            <a:ext cx="8813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= -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40</a:t>
            </a:r>
            <a:endParaRPr lang="en-US" altLang="ja-JP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029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185842" y="916990"/>
            <a:ext cx="27217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 vascular risk factors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 = 30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正方形/長方形 55"/>
          <p:cNvSpPr/>
          <p:nvPr/>
        </p:nvSpPr>
        <p:spPr>
          <a:xfrm>
            <a:off x="1262247" y="4606649"/>
            <a:ext cx="22722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vascular risk factors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n = 48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1842506" y="6156710"/>
            <a:ext cx="838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A</a:t>
            </a:r>
            <a:endParaRPr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 rot="16200000">
            <a:off x="186571" y="5297566"/>
            <a:ext cx="1285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mΔeGFR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1370136" y="598609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1752281" y="5991265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2133874" y="5986854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2473544" y="5986854"/>
            <a:ext cx="370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996933" y="490418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1072563" y="5287237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953232" y="5670184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2523404" y="4057444"/>
            <a:ext cx="4937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1391710" y="404786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1773855" y="4047863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2155448" y="4048618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1018507" y="2965947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1094137" y="3349001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テキスト ボックス 127"/>
          <p:cNvSpPr txBox="1"/>
          <p:nvPr/>
        </p:nvSpPr>
        <p:spPr>
          <a:xfrm>
            <a:off x="974806" y="3731948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テキスト ボックス 143"/>
          <p:cNvSpPr txBox="1"/>
          <p:nvPr/>
        </p:nvSpPr>
        <p:spPr>
          <a:xfrm>
            <a:off x="1333546" y="783866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テキスト ボックス 144"/>
          <p:cNvSpPr txBox="1"/>
          <p:nvPr/>
        </p:nvSpPr>
        <p:spPr>
          <a:xfrm>
            <a:off x="1715691" y="7838668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テキスト ボックス 145"/>
          <p:cNvSpPr txBox="1"/>
          <p:nvPr/>
        </p:nvSpPr>
        <p:spPr>
          <a:xfrm>
            <a:off x="2106809" y="7839423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/>
          <p:cNvSpPr txBox="1"/>
          <p:nvPr/>
        </p:nvSpPr>
        <p:spPr>
          <a:xfrm>
            <a:off x="960343" y="6756752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1035973" y="7139806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916642" y="7522753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2445664" y="7829090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1358196" y="220951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1740341" y="2209512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2131459" y="2210267"/>
            <a:ext cx="7106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984993" y="1127596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1060623" y="1510650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941292" y="1893597"/>
            <a:ext cx="5951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2470314" y="2199934"/>
            <a:ext cx="3717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548" y="4963758"/>
            <a:ext cx="1471433" cy="1066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8072366"/>
              </p:ext>
            </p:extLst>
          </p:nvPr>
        </p:nvGraphicFramePr>
        <p:xfrm>
          <a:off x="3634570" y="5077608"/>
          <a:ext cx="2520351" cy="9615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4271"/>
                <a:gridCol w="576080"/>
              </a:tblGrid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scular</a:t>
                      </a:r>
                      <a:r>
                        <a:rPr kumimoji="1" lang="ja-JP" alt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factor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normal cholesterol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vel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 mellitu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57" name="表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708"/>
              </p:ext>
            </p:extLst>
          </p:nvPr>
        </p:nvGraphicFramePr>
        <p:xfrm>
          <a:off x="3642032" y="6808317"/>
          <a:ext cx="2520351" cy="10976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4271"/>
                <a:gridCol w="576080"/>
              </a:tblGrid>
              <a:tr h="21953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scular</a:t>
                      </a:r>
                      <a:r>
                        <a:rPr kumimoji="1" lang="ja-JP" alt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factor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953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953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 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953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normal cholesterol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vel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1953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 mellitu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4" name="正方形/長方形 53"/>
          <p:cNvSpPr/>
          <p:nvPr/>
        </p:nvSpPr>
        <p:spPr>
          <a:xfrm>
            <a:off x="2645940" y="4883648"/>
            <a:ext cx="93098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 = -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24</a:t>
            </a:r>
            <a:endParaRPr lang="en-US" altLang="ja-JP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altLang="ja-JP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 = </a:t>
            </a:r>
            <a:r>
              <a:rPr lang="en-US" altLang="ja-JP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  <a:endParaRPr lang="ja-JP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5" name="表 5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1906968"/>
              </p:ext>
            </p:extLst>
          </p:nvPr>
        </p:nvGraphicFramePr>
        <p:xfrm>
          <a:off x="3645029" y="3139709"/>
          <a:ext cx="2520351" cy="9521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4271"/>
                <a:gridCol w="576080"/>
              </a:tblGrid>
              <a:tr h="151865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scular</a:t>
                      </a:r>
                      <a:r>
                        <a:rPr kumimoji="1" lang="ja-JP" alt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isk factor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BP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ja-JP" altLang="en-US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≥ </a:t>
                      </a:r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0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normal cholesterol</a:t>
                      </a:r>
                      <a:r>
                        <a:rPr kumimoji="1" lang="en-US" altLang="ja-JP" sz="1200" b="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vel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92307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abetes mellitus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38724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</TotalTime>
  <Words>163</Words>
  <Application>Microsoft Office PowerPoint</Application>
  <PresentationFormat>A4 210 x 297 mm</PresentationFormat>
  <Paragraphs>79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血液浄化療法部</dc:creator>
  <cp:lastModifiedBy>血液浄化療法部</cp:lastModifiedBy>
  <cp:revision>9</cp:revision>
  <dcterms:created xsi:type="dcterms:W3CDTF">2016-06-03T07:07:30Z</dcterms:created>
  <dcterms:modified xsi:type="dcterms:W3CDTF">2017-03-24T08:35:36Z</dcterms:modified>
</cp:coreProperties>
</file>